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480175" cy="8688388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4660"/>
  </p:normalViewPr>
  <p:slideViewPr>
    <p:cSldViewPr showGuides="1">
      <p:cViewPr>
        <p:scale>
          <a:sx n="125" d="100"/>
          <a:sy n="125" d="100"/>
        </p:scale>
        <p:origin x="-1020" y="774"/>
      </p:cViewPr>
      <p:guideLst>
        <p:guide orient="horz"/>
        <p:guide pos="37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F908A7-845E-4678-AD23-8FDB7B813C5B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685800"/>
            <a:ext cx="25590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46FAB2-06A0-4723-9144-E4F301473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6348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486013" y="2699032"/>
            <a:ext cx="5508149" cy="186237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972026" y="4923420"/>
            <a:ext cx="4536123" cy="222036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442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494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330090" y="440454"/>
            <a:ext cx="1032778" cy="939230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29506" y="440454"/>
            <a:ext cx="2992581" cy="939230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5518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289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1889" y="5583095"/>
            <a:ext cx="5508149" cy="17256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1889" y="3682510"/>
            <a:ext cx="5508149" cy="190058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361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29506" y="2568304"/>
            <a:ext cx="2012680" cy="726445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350189" y="2568304"/>
            <a:ext cx="2012679" cy="726445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6281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24009" y="347938"/>
            <a:ext cx="5832158" cy="1448065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24009" y="1944832"/>
            <a:ext cx="2863203" cy="8105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24009" y="2755345"/>
            <a:ext cx="2863203" cy="50058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291839" y="1944832"/>
            <a:ext cx="2864327" cy="8105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291839" y="2755345"/>
            <a:ext cx="2864327" cy="50058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451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7254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4103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24009" y="345927"/>
            <a:ext cx="2131933" cy="147219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533568" y="345927"/>
            <a:ext cx="3622598" cy="741529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24009" y="1818126"/>
            <a:ext cx="2131933" cy="59430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331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70160" y="6081872"/>
            <a:ext cx="3888105" cy="71799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270160" y="776323"/>
            <a:ext cx="3888105" cy="521303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270160" y="6799871"/>
            <a:ext cx="3888105" cy="10196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436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24009" y="347938"/>
            <a:ext cx="5832158" cy="14480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24009" y="2027291"/>
            <a:ext cx="5832158" cy="57339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24009" y="8052849"/>
            <a:ext cx="1512041" cy="4625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214060" y="8052849"/>
            <a:ext cx="2052055" cy="4625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644125" y="8052849"/>
            <a:ext cx="1512041" cy="4625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90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575790" y="6936482"/>
            <a:ext cx="540114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Supplementary Figure 2</a:t>
            </a:r>
            <a:r>
              <a:rPr lang="en-US" altLang="ko-KR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altLang="ko-K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TTAC-0001 inhibits tumor growth in subcutaneous A549 lung cancer model. 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A)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Comparison of tumor growth inhibition by TTAC-0001 or </a:t>
            </a:r>
            <a:r>
              <a:rPr lang="en-US" altLang="ko-KR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bevacizumab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 (1 mg/kg) in nude mice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mean ± SE, </a:t>
            </a:r>
            <a:r>
              <a:rPr lang="en-US" altLang="ko-KR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n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=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7)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containing A549 xenografts. Antibodies were injected every other day for seven times beginning one week after subcutaneous injection of A549 cells. Day 0 represents the first day of antibody injection. The arrow indicates the day of antibody injected.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  <a:r>
              <a:rPr lang="en-US" altLang="ko-KR" sz="1000" dirty="0" smtClean="0"/>
              <a:t>* </a:t>
            </a:r>
            <a:r>
              <a:rPr lang="en-US" altLang="ko-KR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&lt;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05,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r>
              <a:rPr lang="en-US" altLang="ko-KR" sz="1000" dirty="0" smtClean="0"/>
              <a:t>* </a:t>
            </a:r>
            <a:r>
              <a:rPr lang="en-US" altLang="ko-KR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&lt;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0.05 vs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ntrol. (B)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Tumors were removed and immediately placed in 10% neutral buffered formalin.  After fixation at room temperature, tissues were processed for paraffin embedding.  Slides were stained with CD31 and terminal </a:t>
            </a:r>
            <a:r>
              <a:rPr lang="en-US" altLang="ko-KR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deoxynucleotidyl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ko-KR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transferase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ko-KR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dUTP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 nick end labeling (all, 400X magnification).</a:t>
            </a:r>
            <a:r>
              <a:rPr lang="en-US" altLang="ko-K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endParaRPr lang="ko-KR" alt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143743" y="0"/>
            <a:ext cx="23230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Supplementary Figure 2.</a:t>
            </a:r>
            <a:r>
              <a:rPr lang="en-US" altLang="ko-KR" sz="1400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 </a:t>
            </a:r>
            <a:endParaRPr lang="ko-KR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026" name="Picture 2" descr="E:\DG_main\TTAC_pharmabcine\Molecular cancer therapy\##Mabs\mAbs 투고\revision\revision final\suppl figure\suppl fig 2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423"/>
          <a:stretch/>
        </p:blipFill>
        <p:spPr bwMode="auto">
          <a:xfrm>
            <a:off x="649967" y="4053840"/>
            <a:ext cx="5182408" cy="28826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9891553"/>
              </p:ext>
            </p:extLst>
          </p:nvPr>
        </p:nvGraphicFramePr>
        <p:xfrm>
          <a:off x="863823" y="334115"/>
          <a:ext cx="4490335" cy="3573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SPW 10.0 Graph" r:id="rId4" imgW="5719320" imgH="4550760" progId="SigmaPlotGraphicObject.9">
                  <p:embed/>
                </p:oleObj>
              </mc:Choice>
              <mc:Fallback>
                <p:oleObj name="SPW 10.0 Graph" r:id="rId4" imgW="5719320" imgH="45507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3823" y="334115"/>
                        <a:ext cx="4490335" cy="3573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100440" y="1897481"/>
            <a:ext cx="18181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ean of Tumor Volume (mm</a:t>
            </a:r>
            <a:r>
              <a:rPr lang="en-US" altLang="ko-KR" sz="900" b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en-US" altLang="ko-KR" sz="9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ko-KR" altLang="en-US" sz="9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TextBox 43"/>
          <p:cNvSpPr txBox="1">
            <a:spLocks noChangeArrowheads="1"/>
          </p:cNvSpPr>
          <p:nvPr/>
        </p:nvSpPr>
        <p:spPr bwMode="auto">
          <a:xfrm>
            <a:off x="626165" y="516970"/>
            <a:ext cx="223244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latinLnBrk="0">
              <a:defRPr/>
            </a:pPr>
            <a:r>
              <a:rPr lang="en-US" altLang="ko-KR" sz="15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kumimoji="0" lang="ko-KR" altLang="en-US" sz="15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624347" y="2699058"/>
            <a:ext cx="3626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/>
              <a:t>***</a:t>
            </a:r>
            <a:endParaRPr lang="ko-KR" altLang="en-US" sz="1100" dirty="0"/>
          </a:p>
        </p:txBody>
      </p:sp>
      <p:sp>
        <p:nvSpPr>
          <p:cNvPr id="10" name="TextBox 9"/>
          <p:cNvSpPr txBox="1"/>
          <p:nvPr/>
        </p:nvSpPr>
        <p:spPr>
          <a:xfrm>
            <a:off x="4646339" y="2593142"/>
            <a:ext cx="3032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/>
              <a:t>**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785667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2</TotalTime>
  <Words>159</Words>
  <Application>Microsoft Office PowerPoint</Application>
  <PresentationFormat>사용자 지정</PresentationFormat>
  <Paragraphs>6</Paragraphs>
  <Slides>1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3" baseType="lpstr">
      <vt:lpstr>Office 테마</vt:lpstr>
      <vt:lpstr>SPW 10.0 Graph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KKU-NS-KDG</dc:creator>
  <cp:lastModifiedBy>donggeon.kim</cp:lastModifiedBy>
  <cp:revision>42</cp:revision>
  <dcterms:created xsi:type="dcterms:W3CDTF">2014-12-16T17:03:05Z</dcterms:created>
  <dcterms:modified xsi:type="dcterms:W3CDTF">2015-06-14T16:50:46Z</dcterms:modified>
</cp:coreProperties>
</file>